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7" r:id="rId3"/>
    <p:sldId id="257" r:id="rId4"/>
    <p:sldId id="256" r:id="rId5"/>
    <p:sldId id="258" r:id="rId6"/>
    <p:sldId id="259" r:id="rId7"/>
    <p:sldId id="268" r:id="rId8"/>
    <p:sldId id="260" r:id="rId9"/>
    <p:sldId id="261" r:id="rId10"/>
    <p:sldId id="262" r:id="rId11"/>
    <p:sldId id="263" r:id="rId12"/>
    <p:sldId id="264" r:id="rId13"/>
    <p:sldId id="266" r:id="rId14"/>
  </p:sldIdLst>
  <p:sldSz cx="12192000" cy="6858000"/>
  <p:notesSz cx="6858000" cy="9144000"/>
  <p:custDataLst>
    <p:tags r:id="rId1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7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8" Type="http://schemas.openxmlformats.org/officeDocument/2006/relationships/tags" Target="tags/tag75.xml"/><Relationship Id="rId17" Type="http://schemas.openxmlformats.org/officeDocument/2006/relationships/tableStyles" Target="tableStyles.xml"/><Relationship Id="rId16" Type="http://schemas.openxmlformats.org/officeDocument/2006/relationships/viewProps" Target="viewProps.xml"/><Relationship Id="rId15" Type="http://schemas.openxmlformats.org/officeDocument/2006/relationships/presProps" Target="presProps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3.xml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72.xml"/><Relationship Id="rId1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73.xml"/><Relationship Id="rId1" Type="http://schemas.openxmlformats.org/officeDocument/2006/relationships/image" Target="../media/image1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74.xml"/><Relationship Id="rId1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4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5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6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7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8.xml"/><Relationship Id="rId1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9.xml"/><Relationship Id="rId1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70.xml"/><Relationship Id="rId1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71.xml"/><Relationship Id="rId1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22195" y="1231265"/>
            <a:ext cx="7426960" cy="373761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978150" y="5163820"/>
            <a:ext cx="768413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 fontAlgn="auto">
              <a:lnSpc>
                <a:spcPct val="200000"/>
              </a:lnSpc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ure S1. The peak number and distribution of peak length in six type of tissues.</a:t>
            </a:r>
            <a:endParaRPr lang="zh-CN" altLang="en-US" sz="1200"/>
          </a:p>
        </p:txBody>
      </p:sp>
    </p:spTree>
    <p:custDataLst>
      <p:tags r:id="rId2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64030" y="1256665"/>
            <a:ext cx="8664575" cy="394271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420495" y="5544820"/>
            <a:ext cx="101580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ure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S10. N</a:t>
            </a:r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ormalized ATAC-seq reads density </a:t>
            </a:r>
            <a:r>
              <a:rPr lang="en-US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cross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± 2kb of centers of ACRs with (w/)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nd without (w/o) TEs in six tissues.</a:t>
            </a:r>
            <a:endParaRPr lang="en-US" altLang="zh-CN"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667760" y="572770"/>
            <a:ext cx="4856480" cy="496252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842010" y="5825490"/>
            <a:ext cx="1062926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ure S11. The difference of the length of ACRs-related TEs.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ll ACR-related TE superfamilies and their randomly selected equivalents were shown. </a:t>
            </a:r>
            <a:endParaRPr lang="zh-CN" altLang="en-US" sz="1200"/>
          </a:p>
        </p:txBody>
      </p:sp>
    </p:spTree>
    <p:custDataLst>
      <p:tags r:id="rId2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24430" y="1185545"/>
            <a:ext cx="7342505" cy="385826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974215" y="5305425"/>
            <a:ext cx="82423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ure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S12.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Motif enrichment of ACRs (with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nd without TE) located around  TSSs of duplicate genes.</a:t>
            </a:r>
            <a:endParaRPr lang="en-US" altLang="zh-CN" sz="1200" b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715645" y="5517515"/>
            <a:ext cx="11035030" cy="829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 fontAlgn="auto">
              <a:lnSpc>
                <a:spcPct val="200000"/>
              </a:lnSpc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ure S2. Normalized TE number across ± 2kb of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CR centers in six tissues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. All ACRs were divided into three groups (high, mid, low) according to their level of accessibility.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zh-CN" altLang="en-US" sz="120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002915" y="1438910"/>
            <a:ext cx="6461125" cy="398081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90905" y="593090"/>
            <a:ext cx="10349230" cy="479933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09245" y="5392420"/>
            <a:ext cx="11780520" cy="829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 fontAlgn="auto">
              <a:lnSpc>
                <a:spcPct val="200000"/>
              </a:lnSpc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ure S3.  Distribution of ATAC peak coverage by TE sequence (percent of  ATAC peak length composed of TE) in six tissues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.  Different TE su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  <a:sym typeface="+mn-ea"/>
              </a:rPr>
              <a:t>perfamilies were shown. </a:t>
            </a:r>
            <a:endParaRPr lang="zh-CN" altLang="en-US" sz="1200"/>
          </a:p>
        </p:txBody>
      </p:sp>
    </p:spTree>
    <p:custDataLst>
      <p:tags r:id="rId2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03370" y="597535"/>
            <a:ext cx="4584700" cy="522478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453005" y="5822315"/>
            <a:ext cx="919289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just" fontAlgn="auto">
              <a:lnSpc>
                <a:spcPct val="200000"/>
              </a:lnSpc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ure S4. Ratio of ACRs with their summits covered by TEs coming from different su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perfamilies. </a:t>
            </a:r>
            <a:endParaRPr lang="zh-CN" altLang="en-US" sz="1200" b="1"/>
          </a:p>
        </p:txBody>
      </p:sp>
    </p:spTree>
    <p:custDataLst>
      <p:tags r:id="rId2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446145" y="1306830"/>
            <a:ext cx="6568440" cy="31857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985135" y="4759325"/>
            <a:ext cx="675513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S5. Ratio of  different types of ACRs based on the distance to the nearest gene.</a:t>
            </a:r>
            <a:endParaRPr lang="zh-CN" altLang="en-US" sz="1200" b="1"/>
          </a:p>
        </p:txBody>
      </p:sp>
    </p:spTree>
    <p:custDataLst>
      <p:tags r:id="rId2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556260" y="4759960"/>
            <a:ext cx="1142428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Figure S6 The enrichment of three histone marks (H3K4me4, H3K27ac and H3K27me3) in ±2kb flank regions and bodies of TEs with ACRs (w/ ACRs) and (w/o ACRs). </a:t>
            </a:r>
            <a:endParaRPr lang="en-US" altLang="zh-CN"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32485" y="2237740"/>
            <a:ext cx="10527030" cy="225234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6" name="图片 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45105" y="1430655"/>
            <a:ext cx="7251700" cy="357251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369820" y="5219700"/>
            <a:ext cx="8155940" cy="27559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ure S7.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Normalized ATAC-seq reads density across ± 2kb of centers of TE-derived dACRs and pACRs.</a:t>
            </a:r>
            <a:endParaRPr lang="zh-CN" altLang="en-US" sz="1200" b="1"/>
          </a:p>
        </p:txBody>
      </p:sp>
    </p:spTree>
    <p:custDataLst>
      <p:tags r:id="rId2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/>
        </p:nvSpPr>
        <p:spPr>
          <a:xfrm>
            <a:off x="2345055" y="5948045"/>
            <a:ext cx="86048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ure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S8. Chromain </a:t>
            </a:r>
            <a:r>
              <a:rPr lang="en-US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chromatin accessibility signals of all 12,</a:t>
            </a:r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463</a:t>
            </a:r>
            <a:r>
              <a:rPr lang="en-US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tissue-specific ACRs between six tissues.</a:t>
            </a:r>
            <a:endParaRPr lang="en-US" altLang="zh-CN"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880485" y="167005"/>
            <a:ext cx="4947285" cy="568007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622800" y="955675"/>
            <a:ext cx="2748915" cy="403542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822325" y="5583555"/>
            <a:ext cx="106705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ure </a:t>
            </a: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 S9. </a:t>
            </a:r>
            <a:r>
              <a:rPr lang="en-US" sz="1200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Boxplots of log2 fold-change (Max/Min) of chromatin accessibility signals of ACRs with (w/) /without (w/o) TE in six types of tissues.</a:t>
            </a:r>
            <a:endParaRPr lang="en-US" altLang="zh-CN" sz="1200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5.xml><?xml version="1.0" encoding="utf-8"?>
<p:tagLst xmlns:p="http://schemas.openxmlformats.org/presentationml/2006/main">
  <p:tag name="COMMONDATA" val="eyJoZGlkIjoiYmE4NTA3NGI4OTRhNzVlMmMzZWY4YWZjOWZmZWE4ZjgifQ==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41</Words>
  <Application>WPS 演示</Application>
  <PresentationFormat>宽屏</PresentationFormat>
  <Paragraphs>24</Paragraphs>
  <Slides>1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21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艾岑</cp:lastModifiedBy>
  <cp:revision>154</cp:revision>
  <dcterms:created xsi:type="dcterms:W3CDTF">2019-06-19T02:08:00Z</dcterms:created>
  <dcterms:modified xsi:type="dcterms:W3CDTF">2022-08-09T09:33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875</vt:lpwstr>
  </property>
  <property fmtid="{D5CDD505-2E9C-101B-9397-08002B2CF9AE}" pid="3" name="ICV">
    <vt:lpwstr>609B33E80252451F9E7193DE300B195A</vt:lpwstr>
  </property>
</Properties>
</file>